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1" autoAdjust="0"/>
    <p:restoredTop sz="94660"/>
  </p:normalViewPr>
  <p:slideViewPr>
    <p:cSldViewPr snapToGrid="0">
      <p:cViewPr varScale="1">
        <p:scale>
          <a:sx n="45" d="100"/>
          <a:sy n="45" d="100"/>
        </p:scale>
        <p:origin x="24" y="9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2AA68-8A4A-418F-9026-83644CCEC51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59B0D-C14B-4989-80E9-5DD3225BE3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12246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2AA68-8A4A-418F-9026-83644CCEC51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59B0D-C14B-4989-80E9-5DD3225BE3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37015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2AA68-8A4A-418F-9026-83644CCEC51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59B0D-C14B-4989-80E9-5DD3225BE3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03855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2AA68-8A4A-418F-9026-83644CCEC51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59B0D-C14B-4989-80E9-5DD3225BE3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66920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2AA68-8A4A-418F-9026-83644CCEC51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59B0D-C14B-4989-80E9-5DD3225BE3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76083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2AA68-8A4A-418F-9026-83644CCEC51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59B0D-C14B-4989-80E9-5DD3225BE3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55259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2AA68-8A4A-418F-9026-83644CCEC51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59B0D-C14B-4989-80E9-5DD3225BE3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69539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2AA68-8A4A-418F-9026-83644CCEC51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59B0D-C14B-4989-80E9-5DD3225BE3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57771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2AA68-8A4A-418F-9026-83644CCEC51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59B0D-C14B-4989-80E9-5DD3225BE3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64541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2AA68-8A4A-418F-9026-83644CCEC51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59B0D-C14B-4989-80E9-5DD3225BE3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18800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2AA68-8A4A-418F-9026-83644CCEC51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59B0D-C14B-4989-80E9-5DD3225BE3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7781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72AA68-8A4A-418F-9026-83644CCEC514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E59B0D-C14B-4989-80E9-5DD3225BE3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57083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58240" y="592183"/>
            <a:ext cx="8899751" cy="4956085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Rectangle 1"/>
          <p:cNvSpPr>
            <a:spLocks noChangeArrowheads="1"/>
          </p:cNvSpPr>
          <p:nvPr/>
        </p:nvSpPr>
        <p:spPr bwMode="auto">
          <a:xfrm>
            <a:off x="778933" y="5875866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Figure S16.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Correlation between β-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haematin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inhibition activity (log(BIHA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)) and 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anti-malarial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activity (log(IC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­)) for reversed chloroquinolines against resistant strain 7G8</a:t>
            </a: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rPr>
              <a:t> 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982362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4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MS Mincho</vt:lpstr>
      <vt:lpstr>Times New Roman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goc Nguyen</dc:creator>
  <cp:lastModifiedBy>Ngoc Nguyen</cp:lastModifiedBy>
  <cp:revision>2</cp:revision>
  <dcterms:created xsi:type="dcterms:W3CDTF">2020-07-03T16:09:04Z</dcterms:created>
  <dcterms:modified xsi:type="dcterms:W3CDTF">2020-08-04T16:34:10Z</dcterms:modified>
</cp:coreProperties>
</file>